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6"/>
  </p:notesMasterIdLst>
  <p:sldIdLst>
    <p:sldId id="1905" r:id="rId2"/>
    <p:sldId id="1906" r:id="rId3"/>
    <p:sldId id="1904" r:id="rId4"/>
    <p:sldId id="291" r:id="rId5"/>
  </p:sldIdLst>
  <p:sldSz cx="68580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4660"/>
  </p:normalViewPr>
  <p:slideViewPr>
    <p:cSldViewPr snapToGrid="0">
      <p:cViewPr>
        <p:scale>
          <a:sx n="75" d="100"/>
          <a:sy n="75" d="100"/>
        </p:scale>
        <p:origin x="1800" y="-2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5F99DA-A8E3-4E72-A8FE-0A1242EBE070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E7662F-CD37-4BE3-919B-EA6141737D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0003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DCFD30-9837-03D9-8E52-BEA0B4AF01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01BC751C-5AD0-A0A8-95CF-B2E5C5AA5DB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449513" y="1143000"/>
            <a:ext cx="1958975" cy="3086100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DD7BB802-4F26-29A6-8873-F7A4BAFBA9E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62C2DD4-6E57-940A-485F-E635E6D5FBE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85E27-1938-4586-B79E-C7E9070AE49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44766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6C292F-506F-FE2B-3A00-A01DDEF889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1ECB7046-886C-4A93-C37E-AA4D58AFCD6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449513" y="1143000"/>
            <a:ext cx="1958975" cy="3086100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C0C5C80F-B864-D169-0FF7-E0F68877AB0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E034BF9-08E7-82BD-1094-BD3F2AC76EF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85E27-1938-4586-B79E-C7E9070AE49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8713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449513" y="1143000"/>
            <a:ext cx="1958975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85E27-1938-4586-B79E-C7E9070AE49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92840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67462"/>
            <a:ext cx="5829300" cy="375991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672376"/>
            <a:ext cx="5143500" cy="260744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530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5920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74987"/>
            <a:ext cx="1478756" cy="9152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74987"/>
            <a:ext cx="4350544" cy="9152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254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0498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692444"/>
            <a:ext cx="5915025" cy="449240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227345"/>
            <a:ext cx="5915025" cy="236244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082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874937"/>
            <a:ext cx="2914650" cy="68523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874937"/>
            <a:ext cx="2914650" cy="68523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8704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4990"/>
            <a:ext cx="5915025" cy="208745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47443"/>
            <a:ext cx="2901255" cy="12974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944914"/>
            <a:ext cx="2901255" cy="580237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47443"/>
            <a:ext cx="2915543" cy="12974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944914"/>
            <a:ext cx="2915543" cy="580237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5276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102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6608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9984"/>
            <a:ext cx="2211884" cy="251994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54968"/>
            <a:ext cx="3471863" cy="767483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39929"/>
            <a:ext cx="2211884" cy="60023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2674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9984"/>
            <a:ext cx="2211884" cy="251994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54968"/>
            <a:ext cx="3471863" cy="767483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39929"/>
            <a:ext cx="2211884" cy="60023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7408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74990"/>
            <a:ext cx="5915025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874937"/>
            <a:ext cx="5915025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009783"/>
            <a:ext cx="154305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19975D-B94F-4256-99BC-F670C636894D}" type="datetimeFigureOut">
              <a:rPr lang="ko-KR" altLang="en-US" smtClean="0"/>
              <a:t>2025-01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009783"/>
            <a:ext cx="231457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009783"/>
            <a:ext cx="154305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D81280-626B-47AD-9565-4B251264D6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321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FBC90E8-FC76-CD17-73E4-F1126854F01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5E6517E4-28D2-9325-B975-EB0288FE6C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0527992"/>
              </p:ext>
            </p:extLst>
          </p:nvPr>
        </p:nvGraphicFramePr>
        <p:xfrm>
          <a:off x="157802" y="1762723"/>
          <a:ext cx="6405960" cy="3633606"/>
        </p:xfrm>
        <a:graphic>
          <a:graphicData uri="http://schemas.openxmlformats.org/drawingml/2006/table">
            <a:tbl>
              <a:tblPr/>
              <a:tblGrid>
                <a:gridCol w="658957">
                  <a:extLst>
                    <a:ext uri="{9D8B030D-6E8A-4147-A177-3AD203B41FA5}">
                      <a16:colId xmlns:a16="http://schemas.microsoft.com/office/drawing/2014/main" val="1787950225"/>
                    </a:ext>
                  </a:extLst>
                </a:gridCol>
                <a:gridCol w="658957">
                  <a:extLst>
                    <a:ext uri="{9D8B030D-6E8A-4147-A177-3AD203B41FA5}">
                      <a16:colId xmlns:a16="http://schemas.microsoft.com/office/drawing/2014/main" val="4059687192"/>
                    </a:ext>
                  </a:extLst>
                </a:gridCol>
                <a:gridCol w="1267484">
                  <a:extLst>
                    <a:ext uri="{9D8B030D-6E8A-4147-A177-3AD203B41FA5}">
                      <a16:colId xmlns:a16="http://schemas.microsoft.com/office/drawing/2014/main" val="2531317412"/>
                    </a:ext>
                  </a:extLst>
                </a:gridCol>
                <a:gridCol w="1267485">
                  <a:extLst>
                    <a:ext uri="{9D8B030D-6E8A-4147-A177-3AD203B41FA5}">
                      <a16:colId xmlns:a16="http://schemas.microsoft.com/office/drawing/2014/main" val="2179239671"/>
                    </a:ext>
                  </a:extLst>
                </a:gridCol>
                <a:gridCol w="1502587">
                  <a:extLst>
                    <a:ext uri="{9D8B030D-6E8A-4147-A177-3AD203B41FA5}">
                      <a16:colId xmlns:a16="http://schemas.microsoft.com/office/drawing/2014/main" val="2356419721"/>
                    </a:ext>
                  </a:extLst>
                </a:gridCol>
                <a:gridCol w="1050490">
                  <a:extLst>
                    <a:ext uri="{9D8B030D-6E8A-4147-A177-3AD203B41FA5}">
                      <a16:colId xmlns:a16="http://schemas.microsoft.com/office/drawing/2014/main" val="2893809524"/>
                    </a:ext>
                  </a:extLst>
                </a:gridCol>
              </a:tblGrid>
              <a:tr h="245882"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106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altLang="ko-KR" sz="1000" kern="100" baseline="300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t</a:t>
                      </a:r>
                      <a:r>
                        <a:rPr lang="ko-KR" alt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in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 latinLnBrk="1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endParaRPr lang="ko-KR" sz="1200" kern="100" dirty="0">
                        <a:effectLst/>
                        <a:latin typeface="+mn-lt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969" marR="3969" marT="396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1000" kern="100" baseline="300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line or mor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endParaRPr lang="ko-KR" sz="1200" kern="100" dirty="0">
                        <a:effectLst/>
                        <a:latin typeface="+mn-lt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786027"/>
                  </a:ext>
                </a:extLst>
              </a:tr>
              <a:tr h="535534">
                <a:tc rowSpan="3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B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DLB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-CHOP, R-EPOCH, BR</a:t>
                      </a:r>
                      <a:endParaRPr lang="en-US" sz="1000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HAP, R-DHAP, ICE, R-ICE, GDP, R-</a:t>
                      </a:r>
                      <a:r>
                        <a:rPr lang="en-US" altLang="ko-KR" sz="10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emOx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, BR, Pola-BR, R-Len, IVAM, </a:t>
                      </a:r>
                      <a:r>
                        <a:rPr lang="en-US" altLang="ko-KR" sz="1000" kern="100" dirty="0" err="1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xa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BEAM, Pembrolizumab, Nivolumab, Lenalidomide </a:t>
                      </a: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7955621"/>
                  </a:ext>
                </a:extLst>
              </a:tr>
              <a:tr h="380616">
                <a:tc vMerge="1"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F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CVP, R-CVP, R-CHOP, BR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BR, O-Benda, R-Len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847148"/>
                  </a:ext>
                </a:extLst>
              </a:tr>
              <a:tr h="388483">
                <a:tc vMerge="1"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M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-hyper 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VAD, R-CHOP, VR-CAP, BR, R-Len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brutinib, BR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317687"/>
                  </a:ext>
                </a:extLst>
              </a:tr>
              <a:tr h="426624"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PT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CHOP, A-CHP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rentuximab,</a:t>
                      </a:r>
                      <a:r>
                        <a:rPr lang="ko-KR" alt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DP, </a:t>
                      </a:r>
                      <a:r>
                        <a:rPr lang="en-US" altLang="ko-KR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endamustine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, Lenalidomide</a:t>
                      </a:r>
                      <a:endParaRPr lang="en-US" sz="1000" kern="0" dirty="0"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212339"/>
                  </a:ext>
                </a:extLst>
              </a:tr>
              <a:tr h="281896"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NK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/T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VIPD,</a:t>
                      </a:r>
                      <a:r>
                        <a:rPr lang="ko-KR" alt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VIDL,</a:t>
                      </a:r>
                      <a:r>
                        <a:rPr lang="ko-KR" alt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MVP16, SMILE</a:t>
                      </a:r>
                      <a:endParaRPr lang="en-US" sz="1000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mbrolizumab</a:t>
                      </a:r>
                      <a:endParaRPr lang="en-US" sz="1000" kern="0" dirty="0"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722213"/>
                  </a:ext>
                </a:extLst>
              </a:tr>
              <a:tr h="522068"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H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ABVD, A-AVD </a:t>
                      </a:r>
                      <a:endParaRPr lang="ko-KR" altLang="en-US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HAP, ICE,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exa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BEAM, Brentuximab, Nivolumab, Pembrolizumab </a:t>
                      </a:r>
                      <a:endParaRPr lang="ko-KR" altLang="en-US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9567"/>
                  </a:ext>
                </a:extLst>
              </a:tr>
              <a:tr h="273464"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1</a:t>
                      </a:r>
                      <a:r>
                        <a:rPr lang="en-US" sz="1000" kern="12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t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lin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kern="0" baseline="3000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 line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3</a:t>
                      </a:r>
                      <a:r>
                        <a:rPr lang="en-US" sz="1000" kern="0" baseline="3000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rd</a:t>
                      </a: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 lin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000" kern="12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h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line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608463"/>
                  </a:ext>
                </a:extLst>
              </a:tr>
              <a:tr h="579039">
                <a:tc gridSpan="2"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MM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VTD, VA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KRD, KD, 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IRD</a:t>
                      </a: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, RD, Vel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Caelyx</a:t>
                      </a: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, TCD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, MPT 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(C)D, DCEP, DT-PAC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0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aratumumab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99679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3F13658-C249-7C14-4214-C5B79BFBDC05}"/>
              </a:ext>
            </a:extLst>
          </p:cNvPr>
          <p:cNvSpPr txBox="1"/>
          <p:nvPr/>
        </p:nvSpPr>
        <p:spPr>
          <a:xfrm>
            <a:off x="54691" y="1454983"/>
            <a:ext cx="6645506" cy="2215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050" b="1">
                <a:latin typeface="Arial" panose="020B0604020202020204" pitchFamily="34" charset="0"/>
                <a:cs typeface="Arial" panose="020B0604020202020204" pitchFamily="34" charset="0"/>
              </a:rPr>
              <a:t>Table 1.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Pre-transplant treatment according to </a:t>
            </a:r>
            <a:r>
              <a:rPr lang="en-US" altLang="ko-KR" sz="1050" b="1">
                <a:latin typeface="Arial" panose="020B0604020202020204" pitchFamily="34" charset="0"/>
                <a:cs typeface="Arial" panose="020B0604020202020204" pitchFamily="34" charset="0"/>
              </a:rPr>
              <a:t>each lymphoid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malignancy subtypes.</a:t>
            </a:r>
            <a:endParaRPr lang="en-US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697">
            <a:extLst>
              <a:ext uri="{FF2B5EF4-FFF2-40B4-BE49-F238E27FC236}">
                <a16:creationId xmlns:a16="http://schemas.microsoft.com/office/drawing/2014/main" id="{12F5EF66-4EFA-8374-33BE-A3F7B287ACC7}"/>
              </a:ext>
            </a:extLst>
          </p:cNvPr>
          <p:cNvSpPr txBox="1">
            <a:spLocks noChangeAspect="1"/>
          </p:cNvSpPr>
          <p:nvPr/>
        </p:nvSpPr>
        <p:spPr>
          <a:xfrm>
            <a:off x="157803" y="5514023"/>
            <a:ext cx="6813083" cy="369331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BCL, B-cell lymphoma; DLBCL, diffuse large B cell lymphoma; FL, follicular lymphoma; MCL, mantle cell lymphoma; PTCL, peripheral T-cell lymph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K/TCL, NK/T cell lymph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, Hodgkin’s disease; MM, multiple myeloma; R-CHOP, rituximab+cyclophosphamide+doxorubicin+vincristine+prednisolone; R-EPOCH, rituximab+etoposide+doxorubicin+vincristine+cyclophosphamide+prednisolone; BR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uximab+bendamusti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DHA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splatin+cytarabin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DHAP, rituximab+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splatin+cytarabin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ICE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oposide+ifosfamide+carboplatin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ICE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uximab+etoposide+ifosfamide+carboplatin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GD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mcitabine+cisplatin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mOx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uximab+gemcitabine+oxaliplatin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Pola-BR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atuzumab+rituximab+bendamusti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Len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tuximab+lenalidomid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IVAM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osfamide+etoposide+cytarabine+methotrexat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xa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BEAM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xamethasone+carmustine+melphalan+etoposide+cytarabi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CV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osphamide+vincristine+prednisol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CVP, rituximab+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osphamide+vincristine+prednisol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O-Benda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inutuzumab+bendamustine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R-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perCVAD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rituximab+cyclophosphamide+vincristine+doxorubicin+dexamethasone; VR-CA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rtezomib+rituximab+cyclophosphamide+doxorubicin+prednisol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-CH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entuximab+cyclophosphamide+doxorubicin+prednisol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VIP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oposide+ifosfamide+cisplatin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VIDL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oposide+ifosfamide+L-asparaginas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IMVP16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oposide+ifosfamide+methotrexat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SMILE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trexate+ifosfamide+etoposide+dexamethasone+L-asparaginas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BV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orubicin+bleomycin+vinblastine+dacarbazi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A-AV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entuximab+doxorubicin+vinblastine+dacarbazi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VT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rtezomib+thalidomid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VA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ncristine+doxorubicin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KR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filzomib+lenalidomid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K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filzomib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IR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xazomib+lenalidomid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I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xazomib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Vel/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elyx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rtezomib+liposomal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xorubicin; TCD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lidomide+cyclophosphamide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MPT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lphalan+prednisolone+thalidomid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P(C)D, pomalidomide+(cyclophosphamide)+dexamethasone; DCEP,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ophosphamide+etoposide+cisplatin+dexamethasone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DT-PACE, dexamethasone+cisplatin+etoposide+cyclophosphamide+doxorubicin+thalidomide.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505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2BFF06-3E05-F6D4-086E-388142CC42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1697">
            <a:extLst>
              <a:ext uri="{FF2B5EF4-FFF2-40B4-BE49-F238E27FC236}">
                <a16:creationId xmlns:a16="http://schemas.microsoft.com/office/drawing/2014/main" id="{C4D0426A-A1EF-70E9-6149-AFFDD3B30831}"/>
              </a:ext>
            </a:extLst>
          </p:cNvPr>
          <p:cNvSpPr txBox="1">
            <a:spLocks noChangeAspect="1"/>
          </p:cNvSpPr>
          <p:nvPr/>
        </p:nvSpPr>
        <p:spPr>
          <a:xfrm>
            <a:off x="54691" y="6872082"/>
            <a:ext cx="6902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0" fontAlgn="b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lu, 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ludarabine;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l, melphalan;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G, anti-thymocyte globulin; 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u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busulfan</a:t>
            </a:r>
            <a:r>
              <a:rPr lang="en-US" altLang="ko-KR" sz="100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; Cy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cyclophosphamide; TBI, total body </a:t>
            </a:r>
            <a:r>
              <a:rPr lang="en-US" altLang="ko-KR" sz="1000" dirty="0" err="1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irradiation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42845561-E723-D3B5-1080-53472FCA14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4052597"/>
              </p:ext>
            </p:extLst>
          </p:nvPr>
        </p:nvGraphicFramePr>
        <p:xfrm>
          <a:off x="883366" y="3102171"/>
          <a:ext cx="5417196" cy="3700647"/>
        </p:xfrm>
        <a:graphic>
          <a:graphicData uri="http://schemas.openxmlformats.org/drawingml/2006/table">
            <a:tbl>
              <a:tblPr/>
              <a:tblGrid>
                <a:gridCol w="1634596">
                  <a:extLst>
                    <a:ext uri="{9D8B030D-6E8A-4147-A177-3AD203B41FA5}">
                      <a16:colId xmlns:a16="http://schemas.microsoft.com/office/drawing/2014/main" val="1787950225"/>
                    </a:ext>
                  </a:extLst>
                </a:gridCol>
                <a:gridCol w="954655">
                  <a:extLst>
                    <a:ext uri="{9D8B030D-6E8A-4147-A177-3AD203B41FA5}">
                      <a16:colId xmlns:a16="http://schemas.microsoft.com/office/drawing/2014/main" val="1242318670"/>
                    </a:ext>
                  </a:extLst>
                </a:gridCol>
                <a:gridCol w="565589">
                  <a:extLst>
                    <a:ext uri="{9D8B030D-6E8A-4147-A177-3AD203B41FA5}">
                      <a16:colId xmlns:a16="http://schemas.microsoft.com/office/drawing/2014/main" val="381316513"/>
                    </a:ext>
                  </a:extLst>
                </a:gridCol>
                <a:gridCol w="565589">
                  <a:extLst>
                    <a:ext uri="{9D8B030D-6E8A-4147-A177-3AD203B41FA5}">
                      <a16:colId xmlns:a16="http://schemas.microsoft.com/office/drawing/2014/main" val="2063189642"/>
                    </a:ext>
                  </a:extLst>
                </a:gridCol>
                <a:gridCol w="565589">
                  <a:extLst>
                    <a:ext uri="{9D8B030D-6E8A-4147-A177-3AD203B41FA5}">
                      <a16:colId xmlns:a16="http://schemas.microsoft.com/office/drawing/2014/main" val="630206070"/>
                    </a:ext>
                  </a:extLst>
                </a:gridCol>
                <a:gridCol w="565589">
                  <a:extLst>
                    <a:ext uri="{9D8B030D-6E8A-4147-A177-3AD203B41FA5}">
                      <a16:colId xmlns:a16="http://schemas.microsoft.com/office/drawing/2014/main" val="3923870638"/>
                    </a:ext>
                  </a:extLst>
                </a:gridCol>
                <a:gridCol w="565589">
                  <a:extLst>
                    <a:ext uri="{9D8B030D-6E8A-4147-A177-3AD203B41FA5}">
                      <a16:colId xmlns:a16="http://schemas.microsoft.com/office/drawing/2014/main" val="3627774702"/>
                    </a:ext>
                  </a:extLst>
                </a:gridCol>
              </a:tblGrid>
              <a:tr h="326029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onditioning regimen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. of patients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M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K/T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C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200796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+Me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9232751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</a:t>
                      </a: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Mel+ATG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6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7955621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</a:t>
                      </a:r>
                      <a:r>
                        <a:rPr lang="en-US" sz="1000" kern="12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el+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u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847148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</a:t>
                      </a:r>
                      <a:r>
                        <a:rPr lang="en-US" sz="1000" kern="12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el+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y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1317687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 err="1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+Mel+TBI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212339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</a:t>
                      </a:r>
                      <a:r>
                        <a:rPr lang="en-US" altLang="ko-KR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ATG+</a:t>
                      </a: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u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altLang="ko-KR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6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722213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+ATG</a:t>
                      </a: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Cy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BI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9567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lu+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y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608463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G+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u</a:t>
                      </a:r>
                      <a:r>
                        <a:rPr lang="en-US" sz="1000" kern="12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y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7151657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G</a:t>
                      </a: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Cy+TBI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7965355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u+Cy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7785751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y</a:t>
                      </a: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TBI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828202"/>
                  </a:ext>
                </a:extLst>
              </a:tr>
              <a:tr h="259586">
                <a:tc>
                  <a:txBody>
                    <a:bodyPr/>
                    <a:lstStyle/>
                    <a:p>
                      <a:pPr lvl="1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ota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5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1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71252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74232FE-F003-7687-6060-AECE5AD8540B}"/>
              </a:ext>
            </a:extLst>
          </p:cNvPr>
          <p:cNvSpPr txBox="1"/>
          <p:nvPr/>
        </p:nvSpPr>
        <p:spPr>
          <a:xfrm>
            <a:off x="54691" y="2693233"/>
            <a:ext cx="6584234" cy="227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050" b="1">
                <a:latin typeface="Arial" panose="020B0604020202020204" pitchFamily="34" charset="0"/>
                <a:cs typeface="Arial" panose="020B0604020202020204" pitchFamily="34" charset="0"/>
              </a:rPr>
              <a:t>Table 2. Conditioning regimens before allo-SCT.</a:t>
            </a:r>
            <a:endParaRPr lang="en-US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51601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1697">
            <a:extLst>
              <a:ext uri="{FF2B5EF4-FFF2-40B4-BE49-F238E27FC236}">
                <a16:creationId xmlns:a16="http://schemas.microsoft.com/office/drawing/2014/main" id="{58E6D9B3-DA1B-41E1-AAF7-24FEDDEF36DD}"/>
              </a:ext>
            </a:extLst>
          </p:cNvPr>
          <p:cNvSpPr txBox="1">
            <a:spLocks noChangeAspect="1"/>
          </p:cNvSpPr>
          <p:nvPr/>
        </p:nvSpPr>
        <p:spPr>
          <a:xfrm>
            <a:off x="0" y="9921010"/>
            <a:ext cx="690223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0" fontAlgn="b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CL, B cell lymph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, Hodgkin’s disease; MM, multiple myel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K/TCL, NK/T cell lymph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L, T cell lymphoma;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IC, reduced intensity conditioning; MAC, myeloablative conditioning; HLA, human leukocyte antigen; ASCT, autologous stem cell transplantation; GVHD, graft-versus-host disease; NRM, non-relapse mortality.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A37AE0F4-918E-3725-FA7C-56321B7A60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1693743"/>
              </p:ext>
            </p:extLst>
          </p:nvPr>
        </p:nvGraphicFramePr>
        <p:xfrm>
          <a:off x="140416" y="834108"/>
          <a:ext cx="6412784" cy="8691414"/>
        </p:xfrm>
        <a:graphic>
          <a:graphicData uri="http://schemas.openxmlformats.org/drawingml/2006/table">
            <a:tbl>
              <a:tblPr/>
              <a:tblGrid>
                <a:gridCol w="1669334">
                  <a:extLst>
                    <a:ext uri="{9D8B030D-6E8A-4147-A177-3AD203B41FA5}">
                      <a16:colId xmlns:a16="http://schemas.microsoft.com/office/drawing/2014/main" val="1787950225"/>
                    </a:ext>
                  </a:extLst>
                </a:gridCol>
                <a:gridCol w="948690">
                  <a:extLst>
                    <a:ext uri="{9D8B030D-6E8A-4147-A177-3AD203B41FA5}">
                      <a16:colId xmlns:a16="http://schemas.microsoft.com/office/drawing/2014/main" val="2531317412"/>
                    </a:ext>
                  </a:extLst>
                </a:gridCol>
                <a:gridCol w="948690">
                  <a:extLst>
                    <a:ext uri="{9D8B030D-6E8A-4147-A177-3AD203B41FA5}">
                      <a16:colId xmlns:a16="http://schemas.microsoft.com/office/drawing/2014/main" val="2179239671"/>
                    </a:ext>
                  </a:extLst>
                </a:gridCol>
                <a:gridCol w="948690">
                  <a:extLst>
                    <a:ext uri="{9D8B030D-6E8A-4147-A177-3AD203B41FA5}">
                      <a16:colId xmlns:a16="http://schemas.microsoft.com/office/drawing/2014/main" val="1242318670"/>
                    </a:ext>
                  </a:extLst>
                </a:gridCol>
                <a:gridCol w="948690">
                  <a:extLst>
                    <a:ext uri="{9D8B030D-6E8A-4147-A177-3AD203B41FA5}">
                      <a16:colId xmlns:a16="http://schemas.microsoft.com/office/drawing/2014/main" val="2356419721"/>
                    </a:ext>
                  </a:extLst>
                </a:gridCol>
                <a:gridCol w="948690">
                  <a:extLst>
                    <a:ext uri="{9D8B030D-6E8A-4147-A177-3AD203B41FA5}">
                      <a16:colId xmlns:a16="http://schemas.microsoft.com/office/drawing/2014/main" val="2893809524"/>
                    </a:ext>
                  </a:extLst>
                </a:gridCol>
              </a:tblGrid>
              <a:tr h="269679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6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-cell lymphoma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 latinLnBrk="1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endParaRPr lang="ko-KR" sz="1200" kern="100" dirty="0">
                        <a:effectLst/>
                        <a:latin typeface="+mn-lt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969" marR="3969" marT="3969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M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-cell lymphoma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endParaRPr lang="ko-KR" sz="1200" kern="100" dirty="0">
                        <a:effectLst/>
                        <a:latin typeface="+mn-lt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786027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CL, n=2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D, n=3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M, n=9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K</a:t>
                      </a: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/TCL, n=4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CL, n=22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1F1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200796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marL="180975" lvl="1" indent="0"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ge (median, range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2 (25-6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2 (19-39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49 (39-6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6 (22-52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8 (21-6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7955621"/>
                  </a:ext>
                </a:extLst>
              </a:tr>
              <a:tr h="235421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Gender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847148"/>
                  </a:ext>
                </a:extLst>
              </a:tr>
              <a:tr h="235421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al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 (6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altLang="ko-KR" sz="1000" kern="10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 (67)</a:t>
                      </a:r>
                      <a:endParaRPr lang="ko-KR" altLang="ko-KR" sz="10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25)</a:t>
                      </a:r>
                      <a:endParaRPr lang="ko-KR" altLang="ko-KR" sz="1000" kern="10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 (77)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4918665"/>
                  </a:ext>
                </a:extLst>
              </a:tr>
              <a:tr h="235421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emal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 (4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33) 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7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2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0257037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Related donor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6 (8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8 (89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4 (10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 (5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1317687"/>
                  </a:ext>
                </a:extLst>
              </a:tr>
              <a:tr h="392296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Conditioning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212339"/>
                  </a:ext>
                </a:extLst>
              </a:tr>
              <a:tr h="185183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IC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6 (8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 (10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10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 (77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9177509"/>
                  </a:ext>
                </a:extLst>
              </a:tr>
              <a:tr h="185183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AC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2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 (2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1013077"/>
                  </a:ext>
                </a:extLst>
              </a:tr>
              <a:tr h="392296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Transplantation </a:t>
                      </a:r>
                      <a:r>
                        <a:rPr lang="ko-KR" alt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erio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722213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00-2009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 (3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5 (5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 (2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4244687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10-2019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 (6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4 (44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 (64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590712"/>
                  </a:ext>
                </a:extLst>
              </a:tr>
              <a:tr h="214891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020-2023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1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4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6829088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HLA 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atch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9567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ull match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 (4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22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0 (4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6533274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ismatch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 (3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22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 (3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171931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data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 (2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5 (5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18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2671229"/>
                  </a:ext>
                </a:extLst>
              </a:tr>
              <a:tr h="392296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Status 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before transplant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608463"/>
                  </a:ext>
                </a:extLst>
              </a:tr>
              <a:tr h="185183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2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2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 (27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996799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R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10)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22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18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9296973"/>
                  </a:ext>
                </a:extLst>
              </a:tr>
              <a:tr h="196149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3 (6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22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7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41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4036334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/A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5 (5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4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4294685"/>
                  </a:ext>
                </a:extLst>
              </a:tr>
              <a:tr h="392296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Status 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fter transplant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 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7151657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R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 (5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11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 (41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0479919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R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(11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7346139"/>
                  </a:ext>
                </a:extLst>
              </a:tr>
              <a:tr h="196149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D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 (4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67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22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4765554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/A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5 (5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4844503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 ASCT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7965355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2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 (32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7067952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 (7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0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3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10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 (55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3205269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11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4134288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/A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 (56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4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3288760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 GVHD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2459649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cut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3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25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 (41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8186131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hronic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2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11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5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2669631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l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       Cause </a:t>
                      </a: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f death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7785751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RM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2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25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 (32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0828202"/>
                  </a:ext>
                </a:extLst>
              </a:tr>
              <a:tr h="199342"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rogression/relaps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 (40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33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33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50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 latinLnBrk="1">
                        <a:lnSpc>
                          <a:spcPct val="8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000" kern="1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 (41)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587500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51ADF4-66F1-A13F-F21C-A8A8047DAAE7}"/>
              </a:ext>
            </a:extLst>
          </p:cNvPr>
          <p:cNvSpPr txBox="1"/>
          <p:nvPr/>
        </p:nvSpPr>
        <p:spPr>
          <a:xfrm>
            <a:off x="54691" y="540583"/>
            <a:ext cx="6584234" cy="227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050" b="1">
                <a:latin typeface="Arial" panose="020B0604020202020204" pitchFamily="34" charset="0"/>
                <a:cs typeface="Arial" panose="020B0604020202020204" pitchFamily="34" charset="0"/>
              </a:rPr>
              <a:t>Table 3.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aseline patient characteristics in </a:t>
            </a:r>
            <a:r>
              <a:rPr lang="en-US" altLang="ko-KR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llo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-SCT for lymphoid malignancies.</a:t>
            </a:r>
            <a:endParaRPr lang="en-US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5048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4F72091-534D-66C4-8C7F-46D9B44FD4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1697">
            <a:extLst>
              <a:ext uri="{FF2B5EF4-FFF2-40B4-BE49-F238E27FC236}">
                <a16:creationId xmlns:a16="http://schemas.microsoft.com/office/drawing/2014/main" id="{7B86DAB3-A2A6-8C9C-3FCB-ACC3E25438DF}"/>
              </a:ext>
            </a:extLst>
          </p:cNvPr>
          <p:cNvSpPr txBox="1">
            <a:spLocks noChangeAspect="1"/>
          </p:cNvSpPr>
          <p:nvPr/>
        </p:nvSpPr>
        <p:spPr>
          <a:xfrm>
            <a:off x="6459" y="5844032"/>
            <a:ext cx="6851541" cy="634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80000"/>
              </a:lnSpc>
            </a:pPr>
            <a:endParaRPr lang="en-US" altLang="ko-K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80000"/>
              </a:lnSpc>
            </a:pPr>
            <a:r>
              <a:rPr lang="en-US" altLang="ko-KR" sz="110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CL, B cell lymphoma; TCL, T cell lymphoma; NK/TCL, NK/T cell lymphoma; HD, Hodgkin’s disease; MM, multiple myeloma.</a:t>
            </a:r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80000"/>
              </a:lnSpc>
            </a:pPr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F9225847-A908-20AF-664E-EE1D0D0E2E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8059462"/>
              </p:ext>
            </p:extLst>
          </p:nvPr>
        </p:nvGraphicFramePr>
        <p:xfrm>
          <a:off x="123825" y="2824448"/>
          <a:ext cx="6508646" cy="3093052"/>
        </p:xfrm>
        <a:graphic>
          <a:graphicData uri="http://schemas.openxmlformats.org/drawingml/2006/table">
            <a:tbl>
              <a:tblPr/>
              <a:tblGrid>
                <a:gridCol w="1856691">
                  <a:extLst>
                    <a:ext uri="{9D8B030D-6E8A-4147-A177-3AD203B41FA5}">
                      <a16:colId xmlns:a16="http://schemas.microsoft.com/office/drawing/2014/main" val="2531317412"/>
                    </a:ext>
                  </a:extLst>
                </a:gridCol>
                <a:gridCol w="930391">
                  <a:extLst>
                    <a:ext uri="{9D8B030D-6E8A-4147-A177-3AD203B41FA5}">
                      <a16:colId xmlns:a16="http://schemas.microsoft.com/office/drawing/2014/main" val="1071874151"/>
                    </a:ext>
                  </a:extLst>
                </a:gridCol>
                <a:gridCol w="930391">
                  <a:extLst>
                    <a:ext uri="{9D8B030D-6E8A-4147-A177-3AD203B41FA5}">
                      <a16:colId xmlns:a16="http://schemas.microsoft.com/office/drawing/2014/main" val="582192104"/>
                    </a:ext>
                  </a:extLst>
                </a:gridCol>
                <a:gridCol w="930391">
                  <a:extLst>
                    <a:ext uri="{9D8B030D-6E8A-4147-A177-3AD203B41FA5}">
                      <a16:colId xmlns:a16="http://schemas.microsoft.com/office/drawing/2014/main" val="2846262750"/>
                    </a:ext>
                  </a:extLst>
                </a:gridCol>
                <a:gridCol w="930391">
                  <a:extLst>
                    <a:ext uri="{9D8B030D-6E8A-4147-A177-3AD203B41FA5}">
                      <a16:colId xmlns:a16="http://schemas.microsoft.com/office/drawing/2014/main" val="2079453484"/>
                    </a:ext>
                  </a:extLst>
                </a:gridCol>
                <a:gridCol w="930391">
                  <a:extLst>
                    <a:ext uri="{9D8B030D-6E8A-4147-A177-3AD203B41FA5}">
                      <a16:colId xmlns:a16="http://schemas.microsoft.com/office/drawing/2014/main" val="492478781"/>
                    </a:ext>
                  </a:extLst>
                </a:gridCol>
              </a:tblGrid>
              <a:tr h="442003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 </a:t>
                      </a:r>
                    </a:p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0)</a:t>
                      </a:r>
                      <a:endParaRPr lang="ko-KR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L </a:t>
                      </a:r>
                    </a:p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2)</a:t>
                      </a:r>
                      <a:endParaRPr lang="ko-KR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K/TCL </a:t>
                      </a:r>
                    </a:p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4)</a:t>
                      </a:r>
                      <a:endParaRPr lang="ko-KR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</a:p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)</a:t>
                      </a:r>
                      <a:endParaRPr lang="ko-KR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)</a:t>
                      </a:r>
                      <a:endParaRPr lang="ko-KR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4150194"/>
                  </a:ext>
                </a:extLst>
              </a:tr>
              <a:tr h="508632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5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 (18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5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3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1373956"/>
                  </a:ext>
                </a:extLst>
              </a:tr>
              <a:tr h="477804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t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8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3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1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3768144"/>
                  </a:ext>
                </a:extLst>
              </a:tr>
              <a:tr h="554871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5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8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5146885"/>
                  </a:ext>
                </a:extLst>
              </a:tr>
              <a:tr h="554871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ute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5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3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3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3079121"/>
                  </a:ext>
                </a:extLst>
              </a:tr>
              <a:tr h="554871"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nic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0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5)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50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271232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B230E85-BB11-B7E6-5300-542B4B5B71BA}"/>
              </a:ext>
            </a:extLst>
          </p:cNvPr>
          <p:cNvSpPr txBox="1"/>
          <p:nvPr/>
        </p:nvSpPr>
        <p:spPr>
          <a:xfrm>
            <a:off x="12914" y="2596693"/>
            <a:ext cx="6902236" cy="227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. GVHD characteristics in </a:t>
            </a:r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llo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-SCT recipients for lymphoid malignancies.</a:t>
            </a:r>
          </a:p>
        </p:txBody>
      </p:sp>
    </p:spTree>
    <p:extLst>
      <p:ext uri="{BB962C8B-B14F-4D97-AF65-F5344CB8AC3E}">
        <p14:creationId xmlns:p14="http://schemas.microsoft.com/office/powerpoint/2010/main" val="2910486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</TotalTime>
  <Words>1548</Words>
  <Application>Microsoft Office PowerPoint</Application>
  <PresentationFormat>사용자 지정</PresentationFormat>
  <Paragraphs>353</Paragraphs>
  <Slides>4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ptos</vt:lpstr>
      <vt:lpstr>Aptos Display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선용</dc:creator>
  <cp:lastModifiedBy>김선용</cp:lastModifiedBy>
  <cp:revision>24</cp:revision>
  <dcterms:created xsi:type="dcterms:W3CDTF">2024-08-30T01:40:52Z</dcterms:created>
  <dcterms:modified xsi:type="dcterms:W3CDTF">2025-01-08T05:39:39Z</dcterms:modified>
</cp:coreProperties>
</file>